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91" d="100"/>
          <a:sy n="91" d="100"/>
        </p:scale>
        <p:origin x="53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8922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1298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8525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9666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89333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1885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6572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1006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6914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9953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5373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38431-0AE1-4A44-9720-8164462E3D56}" type="datetimeFigureOut">
              <a:rPr lang="ko-KR" altLang="en-US" smtClean="0"/>
              <a:t>2016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1CE286-881A-4EEA-89A3-E2AD0BA736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1591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313354" y="271448"/>
            <a:ext cx="5565292" cy="555701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13509" y="5828459"/>
            <a:ext cx="107649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A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checking the normality of log-transformed gene expressions, we performed Shapiro-Wilks test for each gene and dr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 a histogram of the p-values. P-values for most genes are larger than 0.05 which means log-transformed gene expressions follow normal distributions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2383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TextBox 4"/>
          <p:cNvSpPr txBox="1"/>
          <p:nvPr/>
        </p:nvSpPr>
        <p:spPr>
          <a:xfrm>
            <a:off x="713509" y="5748904"/>
            <a:ext cx="10764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B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Q-plots for some genes which are significant in model-based approach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내용 개체 틀 8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57695" y="207183"/>
            <a:ext cx="11636974" cy="5337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43269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ko-KR" altLang="en-US"/>
          </a:p>
        </p:txBody>
      </p:sp>
      <p:pic>
        <p:nvPicPr>
          <p:cNvPr id="8" name="내용 개체 틀 7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92411" y="121430"/>
            <a:ext cx="10557795" cy="57347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88818" y="5934670"/>
            <a:ext cx="107649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C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profiles for significant genes with leptin detected by model-based approach. Blue dots are ND samples and Red dots are HFD samples. X-axis shows log-normalized gene expression for each gene and Y-axis shows expression of leptin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67349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ko-KR" altLang="en-US"/>
          </a:p>
        </p:txBody>
      </p:sp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71189" y="452092"/>
            <a:ext cx="11849622" cy="455823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88818" y="5934670"/>
            <a:ext cx="107649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D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profiles for significant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with adiponectin detected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model-based approach. Blue dots show ND samples and Red dots show HFD samples. X-axis shows log-normalized gene expression for each gene and Y-axis shows expression of adiponectin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37071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ko-KR" altLang="en-US"/>
          </a:p>
        </p:txBody>
      </p:sp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43339" y="208403"/>
            <a:ext cx="11305322" cy="434885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88818" y="5676976"/>
            <a:ext cx="107649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E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profiles for significant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with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sulin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ed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model-based approach. Blue dots are ND samples and Red dots are HFD samples. X-axis shows log-normalized gene expression for each gene and Y-axis shows expression of insulin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6378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187</Words>
  <Application>Microsoft Office PowerPoint</Application>
  <PresentationFormat>와이드스크린</PresentationFormat>
  <Paragraphs>5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9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ngkang Kim</dc:creator>
  <cp:lastModifiedBy>Yongkang Kim</cp:lastModifiedBy>
  <cp:revision>20</cp:revision>
  <dcterms:created xsi:type="dcterms:W3CDTF">2016-01-05T16:16:11Z</dcterms:created>
  <dcterms:modified xsi:type="dcterms:W3CDTF">2016-01-31T13:22:29Z</dcterms:modified>
</cp:coreProperties>
</file>